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6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3840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131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8402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456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2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011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479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982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6422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1897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182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B2A60-BC50-48FB-BEBC-84516424151D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F7922-FF23-4340-A3AD-432D5BDA4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20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2C68F74A-2C79-40CE-A026-B9A423185551}"/>
              </a:ext>
            </a:extLst>
          </p:cNvPr>
          <p:cNvGraphicFramePr>
            <a:graphicFrameLocks noGrp="1"/>
          </p:cNvGraphicFramePr>
          <p:nvPr/>
        </p:nvGraphicFramePr>
        <p:xfrm>
          <a:off x="106325" y="1106680"/>
          <a:ext cx="6655982" cy="4614544"/>
        </p:xfrm>
        <a:graphic>
          <a:graphicData uri="http://schemas.openxmlformats.org/drawingml/2006/table">
            <a:tbl>
              <a:tblPr/>
              <a:tblGrid>
                <a:gridCol w="768252">
                  <a:extLst>
                    <a:ext uri="{9D8B030D-6E8A-4147-A177-3AD203B41FA5}">
                      <a16:colId xmlns:a16="http://schemas.microsoft.com/office/drawing/2014/main" val="139660482"/>
                    </a:ext>
                  </a:extLst>
                </a:gridCol>
                <a:gridCol w="2943865">
                  <a:extLst>
                    <a:ext uri="{9D8B030D-6E8A-4147-A177-3AD203B41FA5}">
                      <a16:colId xmlns:a16="http://schemas.microsoft.com/office/drawing/2014/main" val="1237572013"/>
                    </a:ext>
                  </a:extLst>
                </a:gridCol>
                <a:gridCol w="2943865">
                  <a:extLst>
                    <a:ext uri="{9D8B030D-6E8A-4147-A177-3AD203B41FA5}">
                      <a16:colId xmlns:a16="http://schemas.microsoft.com/office/drawing/2014/main" val="2846377940"/>
                    </a:ext>
                  </a:extLst>
                </a:gridCol>
              </a:tblGrid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enes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2114210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DN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TCAGTTGGCCTTTGGATACC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nl-NL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GCAGATAAAAAGACTGC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9789803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G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nl-NL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GTCAAGGGAATGCTG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  <a:endParaRPr lang="nl-NL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CAGAACCGTACACAG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1740786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T-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CACCATCTGTTTGGA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CGGAAGACTCTCTCAA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512599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DN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nl-NL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AAGGACACCAGCCCTG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  <a:endParaRPr lang="nl-NL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CCAGCTACAGAAAACTG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2476970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G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CATCTATGTGGGGCTTC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GATGCTGGCCTGTCTCC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  <a:endParaRPr lang="en-US" altLang="ja-JP" sz="12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252452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NT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CAGAAGCGCCATTAAC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ACTTCCATCAGGCAA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6865411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GF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GTGACCGGTAAGTATTG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TGCTGGCTTCTAAGTG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3612602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GF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TTTGGATTTTGCCAGA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GTGCCACTGTCCATGTCATC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7633931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EG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TGGGTTTGTCGTGTT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GAGGCCGAAGTCCTTT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8126217"/>
                  </a:ext>
                </a:extLst>
              </a:tr>
              <a:tr h="419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β-act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TGCTTCTAGGCGGACTGTTACTG-3’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CTGCGCAAGTTAGGTTTTGTCA-3’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6118844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3E3BC00-5B01-4420-B3B6-0019BF6CAE85}"/>
              </a:ext>
            </a:extLst>
          </p:cNvPr>
          <p:cNvSpPr txBox="1"/>
          <p:nvPr/>
        </p:nvSpPr>
        <p:spPr>
          <a:xfrm>
            <a:off x="106325" y="627394"/>
            <a:ext cx="65357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table 1. Primer sets used for quantitative RT-PCR.</a:t>
            </a:r>
            <a:endParaRPr lang="ja-JP" altLang="ja-JP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0693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5182DF3E-E510-48F7-B857-2E9F3E9182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9812405"/>
              </p:ext>
            </p:extLst>
          </p:nvPr>
        </p:nvGraphicFramePr>
        <p:xfrm>
          <a:off x="885838" y="2219567"/>
          <a:ext cx="4775200" cy="3275141"/>
        </p:xfrm>
        <a:graphic>
          <a:graphicData uri="http://schemas.openxmlformats.org/drawingml/2006/table">
            <a:tbl>
              <a:tblPr/>
              <a:tblGrid>
                <a:gridCol w="1422400">
                  <a:extLst>
                    <a:ext uri="{9D8B030D-6E8A-4147-A177-3AD203B41FA5}">
                      <a16:colId xmlns:a16="http://schemas.microsoft.com/office/drawing/2014/main" val="4023608562"/>
                    </a:ext>
                  </a:extLst>
                </a:gridCol>
                <a:gridCol w="1422400">
                  <a:extLst>
                    <a:ext uri="{9D8B030D-6E8A-4147-A177-3AD203B41FA5}">
                      <a16:colId xmlns:a16="http://schemas.microsoft.com/office/drawing/2014/main" val="336992720"/>
                    </a:ext>
                  </a:extLst>
                </a:gridCol>
                <a:gridCol w="1930400">
                  <a:extLst>
                    <a:ext uri="{9D8B030D-6E8A-4147-A177-3AD203B41FA5}">
                      <a16:colId xmlns:a16="http://schemas.microsoft.com/office/drawing/2014/main" val="1516292082"/>
                    </a:ext>
                  </a:extLst>
                </a:gridCol>
              </a:tblGrid>
              <a:tr h="3167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ene</a:t>
                      </a:r>
                    </a:p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roup</a:t>
                      </a:r>
                    </a:p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elative mRNA expression</a:t>
                      </a:r>
                    </a:p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680597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a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0 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4514449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1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6873264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1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a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0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788232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97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9622157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1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a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0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6607226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89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4165468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1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a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0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6834357"/>
                  </a:ext>
                </a:extLst>
              </a:tr>
              <a:tr h="316762"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2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±</a:t>
                      </a: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063559"/>
                  </a:ext>
                </a:extLst>
              </a:tr>
            </a:tbl>
          </a:graphicData>
        </a:graphic>
      </p:graphicFrame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02884A97-D8A6-4284-AC17-8E946153DCCD}"/>
              </a:ext>
            </a:extLst>
          </p:cNvPr>
          <p:cNvCxnSpPr/>
          <p:nvPr/>
        </p:nvCxnSpPr>
        <p:spPr>
          <a:xfrm>
            <a:off x="584200" y="2082801"/>
            <a:ext cx="5689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DD3D6237-3647-45B5-9596-5A9792878691}"/>
              </a:ext>
            </a:extLst>
          </p:cNvPr>
          <p:cNvCxnSpPr/>
          <p:nvPr/>
        </p:nvCxnSpPr>
        <p:spPr>
          <a:xfrm>
            <a:off x="584200" y="2844801"/>
            <a:ext cx="5689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58E8F21E-4004-40F1-BCE9-D576954F6672}"/>
              </a:ext>
            </a:extLst>
          </p:cNvPr>
          <p:cNvCxnSpPr/>
          <p:nvPr/>
        </p:nvCxnSpPr>
        <p:spPr>
          <a:xfrm>
            <a:off x="584200" y="5613401"/>
            <a:ext cx="5689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460DBC2-FCE2-4643-BCD8-046F203301F2}"/>
              </a:ext>
            </a:extLst>
          </p:cNvPr>
          <p:cNvSpPr txBox="1"/>
          <p:nvPr/>
        </p:nvSpPr>
        <p:spPr>
          <a:xfrm>
            <a:off x="489405" y="1374761"/>
            <a:ext cx="587918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table 2. The hippocampal </a:t>
            </a:r>
            <a:r>
              <a:rPr lang="en-US" altLang="ja-JP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RNA expression related to inflammation  </a:t>
            </a:r>
            <a:endParaRPr lang="ja-JP" altLang="ja-JP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6B75123-8387-416B-A636-285098532E33}"/>
              </a:ext>
            </a:extLst>
          </p:cNvPr>
          <p:cNvSpPr txBox="1"/>
          <p:nvPr/>
        </p:nvSpPr>
        <p:spPr>
          <a:xfrm>
            <a:off x="489405" y="5724120"/>
            <a:ext cx="587918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l values are mean ±</a:t>
            </a:r>
            <a:r>
              <a:rPr lang="ja-JP" alt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EM (n = 4). No significant difference was observed between the control and RM groups. RM: rice-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molin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endParaRPr lang="ja-JP" altLang="ja-JP" sz="14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9791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63FCD94-2AAA-4201-A64A-DD341A6B1CB6}"/>
              </a:ext>
            </a:extLst>
          </p:cNvPr>
          <p:cNvGrpSpPr>
            <a:grpSpLocks noChangeAspect="1"/>
          </p:cNvGrpSpPr>
          <p:nvPr/>
        </p:nvGrpSpPr>
        <p:grpSpPr>
          <a:xfrm>
            <a:off x="680187" y="2156399"/>
            <a:ext cx="5825535" cy="3696251"/>
            <a:chOff x="-1" y="970149"/>
            <a:chExt cx="9144001" cy="5801788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0C92312-DFBB-480F-AADA-2EB424B395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" y="1088681"/>
              <a:ext cx="4401671" cy="5683256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BE8543D4-66EA-47FB-A5F7-54E7E98D3F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42329" y="1088681"/>
              <a:ext cx="4401671" cy="5639222"/>
            </a:xfrm>
            <a:prstGeom prst="rect">
              <a:avLst/>
            </a:prstGeom>
          </p:spPr>
        </p:pic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B0873823-1182-4683-831E-20B37ECDB6AF}"/>
                </a:ext>
              </a:extLst>
            </p:cNvPr>
            <p:cNvSpPr/>
            <p:nvPr/>
          </p:nvSpPr>
          <p:spPr>
            <a:xfrm>
              <a:off x="0" y="982133"/>
              <a:ext cx="1278467" cy="1693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EB1B90BB-DADD-4A94-8549-4A1185EB96B1}"/>
                </a:ext>
              </a:extLst>
            </p:cNvPr>
            <p:cNvSpPr/>
            <p:nvPr/>
          </p:nvSpPr>
          <p:spPr>
            <a:xfrm>
              <a:off x="4697504" y="970149"/>
              <a:ext cx="1677896" cy="1693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8AC75FC-188B-4B76-B0EF-C81AAD1E5313}"/>
              </a:ext>
            </a:extLst>
          </p:cNvPr>
          <p:cNvSpPr txBox="1"/>
          <p:nvPr/>
        </p:nvSpPr>
        <p:spPr>
          <a:xfrm>
            <a:off x="164097" y="1490221"/>
            <a:ext cx="27863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. Before digestion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CDF972D-7381-47C2-A851-5637717478C6}"/>
              </a:ext>
            </a:extLst>
          </p:cNvPr>
          <p:cNvSpPr txBox="1"/>
          <p:nvPr/>
        </p:nvSpPr>
        <p:spPr>
          <a:xfrm>
            <a:off x="3701469" y="1490221"/>
            <a:ext cx="2511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B. After digestion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213D368-E67C-4497-93CC-25E0F2F1B7B7}"/>
              </a:ext>
            </a:extLst>
          </p:cNvPr>
          <p:cNvSpPr txBox="1"/>
          <p:nvPr/>
        </p:nvSpPr>
        <p:spPr>
          <a:xfrm>
            <a:off x="1775276" y="5901475"/>
            <a:ext cx="107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T (min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63C954-C202-4117-9811-3F83E69793BC}"/>
              </a:ext>
            </a:extLst>
          </p:cNvPr>
          <p:cNvSpPr txBox="1"/>
          <p:nvPr/>
        </p:nvSpPr>
        <p:spPr>
          <a:xfrm>
            <a:off x="4830286" y="5901475"/>
            <a:ext cx="107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T (min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06E53D6-8CBE-4E10-B0EF-7A2DBA0A4BB1}"/>
              </a:ext>
            </a:extLst>
          </p:cNvPr>
          <p:cNvSpPr txBox="1"/>
          <p:nvPr/>
        </p:nvSpPr>
        <p:spPr>
          <a:xfrm rot="16200000">
            <a:off x="-106068" y="3781416"/>
            <a:ext cx="1138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BA0F339-2721-4171-BDFF-FA20B3D810EA}"/>
              </a:ext>
            </a:extLst>
          </p:cNvPr>
          <p:cNvSpPr txBox="1"/>
          <p:nvPr/>
        </p:nvSpPr>
        <p:spPr>
          <a:xfrm>
            <a:off x="12609" y="315513"/>
            <a:ext cx="35670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C116898-5F03-4FD0-80D3-7D2F2712B096}"/>
              </a:ext>
            </a:extLst>
          </p:cNvPr>
          <p:cNvSpPr/>
          <p:nvPr/>
        </p:nvSpPr>
        <p:spPr>
          <a:xfrm>
            <a:off x="520849" y="6504079"/>
            <a:ext cx="592718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epsin and pancreatin digests of VYTPG and LCMS analysis were performed in a similar manner to previous studies 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hobako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et al, 2018b) with slight modifications to simulate peptide bioavailability. Each enzyme treatment </a:t>
            </a:r>
            <a:r>
              <a:rPr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time was 1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. TICs for LCM analysis are shown above.</a:t>
            </a:r>
          </a:p>
        </p:txBody>
      </p:sp>
    </p:spTree>
    <p:extLst>
      <p:ext uri="{BB962C8B-B14F-4D97-AF65-F5344CB8AC3E}">
        <p14:creationId xmlns:p14="http://schemas.microsoft.com/office/powerpoint/2010/main" val="1097757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258</Words>
  <Application>Microsoft Office PowerPoint</Application>
  <PresentationFormat>A4 210 x 297 mm</PresentationFormat>
  <Paragraphs>6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2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箱 麻衣子</dc:creator>
  <cp:lastModifiedBy>Kousaku Ohinata</cp:lastModifiedBy>
  <cp:revision>13</cp:revision>
  <dcterms:created xsi:type="dcterms:W3CDTF">2022-02-01T06:12:15Z</dcterms:created>
  <dcterms:modified xsi:type="dcterms:W3CDTF">2022-12-13T04:53:29Z</dcterms:modified>
</cp:coreProperties>
</file>